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9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図 39"/>
          <p:cNvPicPr>
            <a:picLocks noChangeAspect="1"/>
          </p:cNvPicPr>
          <p:nvPr/>
        </p:nvPicPr>
        <p:blipFill>
          <a:blip r:embed="rId2"/>
          <a:srcRect t="20247"/>
          <a:stretch>
            <a:fillRect/>
          </a:stretch>
        </p:blipFill>
        <p:spPr>
          <a:xfrm>
            <a:off x="3530769" y="2121486"/>
            <a:ext cx="2417826" cy="1414437"/>
          </a:xfrm>
          <a:prstGeom prst="rect">
            <a:avLst/>
          </a:prstGeom>
        </p:spPr>
      </p:pic>
      <p:pic>
        <p:nvPicPr>
          <p:cNvPr id="41" name="図 40"/>
          <p:cNvPicPr>
            <a:picLocks noChangeAspect="1"/>
          </p:cNvPicPr>
          <p:nvPr/>
        </p:nvPicPr>
        <p:blipFill>
          <a:blip r:embed="rId3"/>
          <a:srcRect t="20247"/>
          <a:stretch>
            <a:fillRect/>
          </a:stretch>
        </p:blipFill>
        <p:spPr>
          <a:xfrm>
            <a:off x="957371" y="2121486"/>
            <a:ext cx="2417826" cy="1414437"/>
          </a:xfrm>
          <a:prstGeom prst="rect">
            <a:avLst/>
          </a:prstGeom>
        </p:spPr>
      </p:pic>
      <p:pic>
        <p:nvPicPr>
          <p:cNvPr id="42" name="図 41"/>
          <p:cNvPicPr>
            <a:picLocks noChangeAspect="1"/>
          </p:cNvPicPr>
          <p:nvPr/>
        </p:nvPicPr>
        <p:blipFill>
          <a:blip r:embed="rId4"/>
          <a:srcRect t="17355"/>
          <a:stretch>
            <a:fillRect/>
          </a:stretch>
        </p:blipFill>
        <p:spPr>
          <a:xfrm>
            <a:off x="957371" y="3733907"/>
            <a:ext cx="2417826" cy="1465735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5"/>
          <a:srcRect t="17355"/>
          <a:stretch>
            <a:fillRect/>
          </a:stretch>
        </p:blipFill>
        <p:spPr>
          <a:xfrm>
            <a:off x="3530769" y="3733907"/>
            <a:ext cx="2417826" cy="1465735"/>
          </a:xfrm>
          <a:prstGeom prst="rect">
            <a:avLst/>
          </a:prstGeom>
        </p:spPr>
      </p:pic>
      <p:sp>
        <p:nvSpPr>
          <p:cNvPr id="44" name="テキスト ボックス 43"/>
          <p:cNvSpPr txBox="1"/>
          <p:nvPr/>
        </p:nvSpPr>
        <p:spPr>
          <a:xfrm>
            <a:off x="1942449" y="1820340"/>
            <a:ext cx="6480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Placebo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447530" y="1820340"/>
            <a:ext cx="7763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 smtClean="0">
                <a:latin typeface="Arial"/>
                <a:cs typeface="Arial"/>
              </a:rPr>
              <a:t>Fluoxetine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6" name="円/楕円 45"/>
          <p:cNvSpPr/>
          <p:nvPr/>
        </p:nvSpPr>
        <p:spPr>
          <a:xfrm>
            <a:off x="1602776" y="2313640"/>
            <a:ext cx="64319" cy="64319"/>
          </a:xfrm>
          <a:prstGeom prst="ellipse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609953" y="2238077"/>
            <a:ext cx="69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KF   1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609953" y="2378366"/>
            <a:ext cx="6998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KF 10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円/楕円 50"/>
          <p:cNvSpPr/>
          <p:nvPr/>
        </p:nvSpPr>
        <p:spPr>
          <a:xfrm>
            <a:off x="1602776" y="3977882"/>
            <a:ext cx="64319" cy="64319"/>
          </a:xfrm>
          <a:prstGeom prst="ellipse">
            <a:avLst/>
          </a:prstGeom>
          <a:solidFill>
            <a:schemeClr val="bg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609953" y="3902319"/>
            <a:ext cx="7454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CH 0.5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609953" y="4042608"/>
            <a:ext cx="7454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CH  10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6" name="円/楕円 55"/>
          <p:cNvSpPr/>
          <p:nvPr/>
        </p:nvSpPr>
        <p:spPr>
          <a:xfrm>
            <a:off x="4145573" y="2313640"/>
            <a:ext cx="64319" cy="64319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152750" y="2238077"/>
            <a:ext cx="6998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KF   1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152750" y="2378366"/>
            <a:ext cx="6998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KF 10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9" name="円/楕円 58"/>
          <p:cNvSpPr/>
          <p:nvPr/>
        </p:nvSpPr>
        <p:spPr>
          <a:xfrm>
            <a:off x="4145573" y="3977882"/>
            <a:ext cx="64319" cy="64319"/>
          </a:xfrm>
          <a:prstGeom prst="ellipse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4152750" y="3902319"/>
            <a:ext cx="7454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CH 0.5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152750" y="4042608"/>
            <a:ext cx="7454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CH  10 µM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650303" y="1765870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a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650303" y="3448755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 Bold"/>
                <a:cs typeface="Arial Bold"/>
              </a:rPr>
              <a:t>b</a:t>
            </a:r>
            <a:endParaRPr kumimoji="1" lang="ja-JP" altLang="en-US" sz="1600" dirty="0">
              <a:latin typeface="Arial Bold"/>
              <a:cs typeface="Arial Bold"/>
            </a:endParaRPr>
          </a:p>
        </p:txBody>
      </p:sp>
      <p:sp>
        <p:nvSpPr>
          <p:cNvPr id="68" name="正方形/長方形 67"/>
          <p:cNvSpPr/>
          <p:nvPr/>
        </p:nvSpPr>
        <p:spPr>
          <a:xfrm>
            <a:off x="1975446" y="3199484"/>
            <a:ext cx="972000" cy="6032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正方形/長方形 68"/>
          <p:cNvSpPr/>
          <p:nvPr/>
        </p:nvSpPr>
        <p:spPr>
          <a:xfrm>
            <a:off x="4548750" y="3199484"/>
            <a:ext cx="972000" cy="6032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正方形/長方形 69"/>
          <p:cNvSpPr/>
          <p:nvPr/>
        </p:nvSpPr>
        <p:spPr>
          <a:xfrm>
            <a:off x="1975446" y="4861607"/>
            <a:ext cx="972000" cy="6032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/>
          <p:cNvSpPr/>
          <p:nvPr/>
        </p:nvSpPr>
        <p:spPr>
          <a:xfrm>
            <a:off x="4548750" y="4861607"/>
            <a:ext cx="972000" cy="6032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000850" y="3278859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5573289" y="3278859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000850" y="4937807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5573289" y="4937807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(min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1877191" y="301579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KF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448041" y="301579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SKF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1877191" y="470013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SCH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4448041" y="4700138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SCH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80" name="二等辺三角形 79"/>
          <p:cNvSpPr>
            <a:spLocks noChangeAspect="1"/>
          </p:cNvSpPr>
          <p:nvPr/>
        </p:nvSpPr>
        <p:spPr>
          <a:xfrm>
            <a:off x="1593251" y="2447978"/>
            <a:ext cx="83520" cy="72000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二等辺三角形 80"/>
          <p:cNvSpPr>
            <a:spLocks noChangeAspect="1"/>
          </p:cNvSpPr>
          <p:nvPr/>
        </p:nvSpPr>
        <p:spPr>
          <a:xfrm>
            <a:off x="1593251" y="4115782"/>
            <a:ext cx="83520" cy="72000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二等辺三角形 81"/>
          <p:cNvSpPr>
            <a:spLocks noChangeAspect="1"/>
          </p:cNvSpPr>
          <p:nvPr/>
        </p:nvSpPr>
        <p:spPr>
          <a:xfrm>
            <a:off x="4138165" y="2447978"/>
            <a:ext cx="83520" cy="72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二等辺三角形 82"/>
          <p:cNvSpPr>
            <a:spLocks noChangeAspect="1"/>
          </p:cNvSpPr>
          <p:nvPr/>
        </p:nvSpPr>
        <p:spPr>
          <a:xfrm>
            <a:off x="4138165" y="4115782"/>
            <a:ext cx="83520" cy="720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625544" y="2884127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769214" y="2978663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4968156" y="2997713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160748" y="3042163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5353558" y="3725754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5160748" y="3912986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4993556" y="3973311"/>
            <a:ext cx="2844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4820014" y="4124996"/>
            <a:ext cx="2345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2027385" y="4263981"/>
            <a:ext cx="2844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2194577" y="4175082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2393519" y="4241757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2587371" y="4136982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2783429" y="4083721"/>
            <a:ext cx="334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/>
                <a:cs typeface="Arial"/>
              </a:rPr>
              <a:t>***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94735" y="5570388"/>
            <a:ext cx="647999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7.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Effects </a:t>
            </a:r>
            <a:r>
              <a:rPr lang="en-US" altLang="ja-JP" sz="1200" b="1" dirty="0">
                <a:latin typeface="Times New Roman"/>
                <a:cs typeface="Times New Roman"/>
              </a:rPr>
              <a:t>of D1 receptor activation or blockade on the basal levels of 5-HT.</a:t>
            </a:r>
            <a:endParaRPr lang="ja-JP" altLang="ja-JP" sz="1200" dirty="0">
              <a:latin typeface="Times New Roman"/>
              <a:cs typeface="Times New Roman"/>
            </a:endParaRPr>
          </a:p>
          <a:p>
            <a:pPr algn="just"/>
            <a:r>
              <a:rPr lang="en-US" altLang="ja-JP" sz="1200" dirty="0">
                <a:latin typeface="Times New Roman"/>
                <a:cs typeface="Times New Roman"/>
              </a:rPr>
              <a:t>(</a:t>
            </a:r>
            <a:r>
              <a:rPr lang="en-US" altLang="ja-JP" sz="1200" b="1" dirty="0">
                <a:latin typeface="Times New Roman"/>
                <a:cs typeface="Times New Roman"/>
              </a:rPr>
              <a:t>a</a:t>
            </a:r>
            <a:r>
              <a:rPr lang="en-US" altLang="ja-JP" sz="1200" dirty="0">
                <a:latin typeface="Times New Roman"/>
                <a:cs typeface="Times New Roman"/>
              </a:rPr>
              <a:t>) Effects of a local infusion of a D1 receptor agonist, R(+)-SKF81297 (SKF; 1 µM, circles; 10 µM, triangles), on the basal 5-HT levels in mice treated with the placebo (1 µM, n = 6; 10 µM, n = 5) or fluoxetine (15 mg/kg/day for 14 days) (1 µM, n = 7; 10 µM, n = 6) pellet. (</a:t>
            </a:r>
            <a:r>
              <a:rPr lang="en-US" altLang="ja-JP" sz="1200" b="1" dirty="0">
                <a:latin typeface="Times New Roman"/>
                <a:cs typeface="Times New Roman"/>
              </a:rPr>
              <a:t>b</a:t>
            </a:r>
            <a:r>
              <a:rPr lang="en-US" altLang="ja-JP" sz="1200" dirty="0">
                <a:latin typeface="Times New Roman"/>
                <a:cs typeface="Times New Roman"/>
              </a:rPr>
              <a:t>) Effects of a local infusion of a D1 receptor antagonist, SCH23390 (0.5 µM, circles; 10 µM, triangles), on the basal 5-HT levels in mice treated with the placebo (0.5 µM, n = 6; 10 µM, n = 5) or fluoxetine (FLX) (0.5 µM, n = 7; 10 µM, n = 6) pellet. The data are expressed as the </a:t>
            </a:r>
            <a:r>
              <a:rPr lang="en-US" altLang="ja-JP" sz="1200" dirty="0" smtClean="0">
                <a:latin typeface="Times New Roman"/>
                <a:cs typeface="Times New Roman"/>
              </a:rPr>
              <a:t>Mean </a:t>
            </a:r>
            <a:r>
              <a:rPr lang="en-US" altLang="ja-JP" sz="1200" dirty="0">
                <a:latin typeface="Times New Roman"/>
                <a:cs typeface="Times New Roman"/>
              </a:rPr>
              <a:t>± S.E.M.</a:t>
            </a:r>
            <a:r>
              <a:rPr lang="en-US" altLang="ja-JP" sz="1200" baseline="30000" dirty="0">
                <a:latin typeface="Times New Roman"/>
                <a:cs typeface="Times New Roman"/>
              </a:rPr>
              <a:t> 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276</Words>
  <Application>Microsoft Macintosh PowerPoint</Application>
  <PresentationFormat>A4 210x297 mm</PresentationFormat>
  <Paragraphs>3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31:14Z</dcterms:modified>
  <cp:category/>
</cp:coreProperties>
</file>